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1644" y="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F:\bZIP\1.bZIP&#25991;&#31456;\4.&#25239;&#26097;&#22522;&#22240;&#31579;&#36873;\&#30456;&#23545;&#21547;&#27700;&#37327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作图!$B$19</c:f>
              <c:strCache>
                <c:ptCount val="1"/>
                <c:pt idx="0">
                  <c:v>control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作图!$D$20:$D$24</c:f>
                <c:numCache>
                  <c:formatCode>General</c:formatCode>
                  <c:ptCount val="5"/>
                  <c:pt idx="0">
                    <c:v>2.4047412382062174</c:v>
                  </c:pt>
                  <c:pt idx="1">
                    <c:v>1.6520161175215657</c:v>
                  </c:pt>
                  <c:pt idx="2">
                    <c:v>2.4714856021074816</c:v>
                  </c:pt>
                  <c:pt idx="3">
                    <c:v>1.8289771407080018</c:v>
                  </c:pt>
                  <c:pt idx="4">
                    <c:v>2.1479642542877575</c:v>
                  </c:pt>
                </c:numCache>
              </c:numRef>
            </c:plus>
            <c:minus>
              <c:numRef>
                <c:f>作图!$D$20:$D$24</c:f>
                <c:numCache>
                  <c:formatCode>General</c:formatCode>
                  <c:ptCount val="5"/>
                  <c:pt idx="0">
                    <c:v>2.4047412382062174</c:v>
                  </c:pt>
                  <c:pt idx="1">
                    <c:v>1.6520161175215657</c:v>
                  </c:pt>
                  <c:pt idx="2">
                    <c:v>2.4714856021074816</c:v>
                  </c:pt>
                  <c:pt idx="3">
                    <c:v>1.8289771407080018</c:v>
                  </c:pt>
                  <c:pt idx="4">
                    <c:v>2.1479642542877575</c:v>
                  </c:pt>
                </c:numCache>
              </c:numRef>
            </c:minus>
          </c:errBars>
          <c:cat>
            <c:strRef>
              <c:f>作图!$A$20:$A$24</c:f>
              <c:strCache>
                <c:ptCount val="5"/>
                <c:pt idx="0">
                  <c:v>3 h</c:v>
                </c:pt>
                <c:pt idx="1">
                  <c:v>6 h</c:v>
                </c:pt>
                <c:pt idx="2">
                  <c:v>12 h</c:v>
                </c:pt>
                <c:pt idx="3">
                  <c:v>24 h</c:v>
                </c:pt>
                <c:pt idx="4">
                  <c:v>48 h</c:v>
                </c:pt>
              </c:strCache>
            </c:strRef>
          </c:cat>
          <c:val>
            <c:numRef>
              <c:f>作图!$B$20:$B$24</c:f>
              <c:numCache>
                <c:formatCode>0.00_);[Red]\(0.00\)</c:formatCode>
                <c:ptCount val="5"/>
                <c:pt idx="0">
                  <c:v>88.957241588820537</c:v>
                </c:pt>
                <c:pt idx="1">
                  <c:v>88.102286885999206</c:v>
                </c:pt>
                <c:pt idx="2">
                  <c:v>86.909861031791351</c:v>
                </c:pt>
                <c:pt idx="3">
                  <c:v>86.714591829681339</c:v>
                </c:pt>
                <c:pt idx="4">
                  <c:v>87.87834972045499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A4A-43A8-989D-4AA6BBFAAEF2}"/>
            </c:ext>
          </c:extLst>
        </c:ser>
        <c:ser>
          <c:idx val="1"/>
          <c:order val="1"/>
          <c:tx>
            <c:strRef>
              <c:f>作图!$E$19</c:f>
              <c:strCache>
                <c:ptCount val="1"/>
                <c:pt idx="0">
                  <c:v>stress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作图!$G$20:$G$24</c:f>
                <c:numCache>
                  <c:formatCode>General</c:formatCode>
                  <c:ptCount val="5"/>
                  <c:pt idx="0">
                    <c:v>2.5459483739361959</c:v>
                  </c:pt>
                  <c:pt idx="1">
                    <c:v>0.3707002296004237</c:v>
                  </c:pt>
                  <c:pt idx="2">
                    <c:v>1.9261527769172615</c:v>
                  </c:pt>
                  <c:pt idx="3">
                    <c:v>1.0409104364293769</c:v>
                  </c:pt>
                  <c:pt idx="4">
                    <c:v>0.74276263420872535</c:v>
                  </c:pt>
                </c:numCache>
              </c:numRef>
            </c:plus>
            <c:minus>
              <c:numRef>
                <c:f>作图!$G$20:$G$24</c:f>
                <c:numCache>
                  <c:formatCode>General</c:formatCode>
                  <c:ptCount val="5"/>
                  <c:pt idx="0">
                    <c:v>2.5459483739361959</c:v>
                  </c:pt>
                  <c:pt idx="1">
                    <c:v>0.3707002296004237</c:v>
                  </c:pt>
                  <c:pt idx="2">
                    <c:v>1.9261527769172615</c:v>
                  </c:pt>
                  <c:pt idx="3">
                    <c:v>1.0409104364293769</c:v>
                  </c:pt>
                  <c:pt idx="4">
                    <c:v>0.74276263420872535</c:v>
                  </c:pt>
                </c:numCache>
              </c:numRef>
            </c:minus>
          </c:errBars>
          <c:cat>
            <c:strRef>
              <c:f>作图!$A$20:$A$24</c:f>
              <c:strCache>
                <c:ptCount val="5"/>
                <c:pt idx="0">
                  <c:v>3 h</c:v>
                </c:pt>
                <c:pt idx="1">
                  <c:v>6 h</c:v>
                </c:pt>
                <c:pt idx="2">
                  <c:v>12 h</c:v>
                </c:pt>
                <c:pt idx="3">
                  <c:v>24 h</c:v>
                </c:pt>
                <c:pt idx="4">
                  <c:v>48 h</c:v>
                </c:pt>
              </c:strCache>
            </c:strRef>
          </c:cat>
          <c:val>
            <c:numRef>
              <c:f>作图!$E$20:$E$24</c:f>
              <c:numCache>
                <c:formatCode>0.00_);[Red]\(0.00\)</c:formatCode>
                <c:ptCount val="5"/>
                <c:pt idx="0">
                  <c:v>92.973642056210849</c:v>
                </c:pt>
                <c:pt idx="1">
                  <c:v>85.112198243929825</c:v>
                </c:pt>
                <c:pt idx="2">
                  <c:v>94.581907519522673</c:v>
                </c:pt>
                <c:pt idx="3">
                  <c:v>77.254015724153064</c:v>
                </c:pt>
                <c:pt idx="4">
                  <c:v>93.1690858161446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BA4A-43A8-989D-4AA6BBFAAEF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07773872"/>
        <c:axId val="307770736"/>
      </c:barChart>
      <c:catAx>
        <c:axId val="30777387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307770736"/>
        <c:crosses val="autoZero"/>
        <c:auto val="1"/>
        <c:lblAlgn val="ctr"/>
        <c:lblOffset val="100"/>
        <c:noMultiLvlLbl val="0"/>
      </c:catAx>
      <c:valAx>
        <c:axId val="307770736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30777387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84955889405537388"/>
          <c:y val="0.44388436029030254"/>
          <c:w val="9.4799442302695366E-2"/>
          <c:h val="0.11223127941939477"/>
        </c:manualLayout>
      </c:layout>
      <c:overlay val="0"/>
      <c:txPr>
        <a:bodyPr/>
        <a:lstStyle/>
        <a:p>
          <a:pPr>
            <a:defRPr>
              <a:latin typeface="Times New Roman" pitchFamily="18" charset="0"/>
              <a:cs typeface="Times New Roman" pitchFamily="18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3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1/3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="" xmlns:a16="http://schemas.microsoft.com/office/drawing/2014/main" id="{E9FC3777-091B-40D0-B7D2-BD900E34B3CC}"/>
              </a:ext>
            </a:extLst>
          </p:cNvPr>
          <p:cNvGrpSpPr/>
          <p:nvPr/>
        </p:nvGrpSpPr>
        <p:grpSpPr>
          <a:xfrm>
            <a:off x="1303930" y="904026"/>
            <a:ext cx="6536140" cy="4847814"/>
            <a:chOff x="1303930" y="904026"/>
            <a:chExt cx="6536140" cy="4847814"/>
          </a:xfrm>
        </p:grpSpPr>
        <p:sp>
          <p:nvSpPr>
            <p:cNvPr id="6" name="TextBox 5"/>
            <p:cNvSpPr txBox="1"/>
            <p:nvPr/>
          </p:nvSpPr>
          <p:spPr>
            <a:xfrm>
              <a:off x="1303930" y="5013176"/>
              <a:ext cx="6536140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 smtClean="0">
                  <a:latin typeface="Times New Roman" pitchFamily="18" charset="0"/>
                  <a:cs typeface="Times New Roman" pitchFamily="18" charset="0"/>
                </a:rPr>
                <a:t>Fig. S4</a:t>
              </a:r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altLang="zh-CN" sz="1400" dirty="0">
                  <a:latin typeface="Times New Roman" pitchFamily="18" charset="0"/>
                  <a:cs typeface="Times New Roman" pitchFamily="18" charset="0"/>
                </a:rPr>
                <a:t>Relative water content </a:t>
              </a:r>
              <a:r>
                <a:rPr lang="en-US" altLang="zh-CN" sz="1400" smtClean="0">
                  <a:latin typeface="Times New Roman" pitchFamily="18" charset="0"/>
                  <a:cs typeface="Times New Roman" pitchFamily="18" charset="0"/>
                </a:rPr>
                <a:t>(RWC) of </a:t>
              </a:r>
              <a:r>
                <a:rPr lang="en-US" altLang="zh-CN" sz="1400" dirty="0">
                  <a:latin typeface="Times New Roman" pitchFamily="18" charset="0"/>
                  <a:cs typeface="Times New Roman" pitchFamily="18" charset="0"/>
                </a:rPr>
                <a:t>ginseng seedlings subjected to PEG stress. The control plants were maintained under normal water irrigation conditions. The values are presented as the means of three replicates. “*”, </a:t>
              </a:r>
              <a:r>
                <a:rPr lang="en-US" altLang="zh-CN" sz="1400" i="1" dirty="0">
                  <a:latin typeface="Times New Roman" pitchFamily="18" charset="0"/>
                  <a:cs typeface="Times New Roman" pitchFamily="18" charset="0"/>
                </a:rPr>
                <a:t>P</a:t>
              </a:r>
              <a:r>
                <a:rPr lang="en-US" altLang="zh-CN" sz="1400" dirty="0">
                  <a:latin typeface="Times New Roman" pitchFamily="18" charset="0"/>
                  <a:cs typeface="Times New Roman" pitchFamily="18" charset="0"/>
                </a:rPr>
                <a:t> ≤ 0.05. 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4115044" y="4698567"/>
              <a:ext cx="146129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Times New Roman" pitchFamily="18" charset="0"/>
                  <a:cs typeface="Times New Roman" pitchFamily="18" charset="0"/>
                </a:rPr>
                <a:t>Treatment Time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 rot="10800000">
              <a:off x="1617636" y="1707554"/>
              <a:ext cx="400110" cy="2232248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400" dirty="0">
                  <a:latin typeface="Times New Roman" pitchFamily="18" charset="0"/>
                  <a:cs typeface="Times New Roman" pitchFamily="18" charset="0"/>
                </a:rPr>
                <a:t>Relative water  content (%)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5434060" y="1480090"/>
              <a:ext cx="38625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 *</a:t>
              </a:r>
              <a:endParaRPr lang="zh-CN" altLang="en-US" dirty="0"/>
            </a:p>
          </p:txBody>
        </p:sp>
        <p:graphicFrame>
          <p:nvGraphicFramePr>
            <p:cNvPr id="8" name="图表 7">
              <a:extLst>
                <a:ext uri="{FF2B5EF4-FFF2-40B4-BE49-F238E27FC236}">
                  <a16:creationId xmlns="" xmlns:a16="http://schemas.microsoft.com/office/drawing/2014/main" id="{00000000-0008-0000-0300-00000200000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291132556"/>
                </p:ext>
              </p:extLst>
            </p:nvPr>
          </p:nvGraphicFramePr>
          <p:xfrm>
            <a:off x="1905668" y="904026"/>
            <a:ext cx="5934402" cy="383930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33928044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52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宋体</vt:lpstr>
      <vt:lpstr>Arial</vt:lpstr>
      <vt:lpstr>Calibri</vt:lpstr>
      <vt:lpstr>Times New Roman</vt:lpstr>
      <vt:lpstr>Office 主题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ENOVO</dc:creator>
  <cp:lastModifiedBy>Zhang, Meiping</cp:lastModifiedBy>
  <cp:revision>12</cp:revision>
  <dcterms:created xsi:type="dcterms:W3CDTF">2019-05-28T01:00:07Z</dcterms:created>
  <dcterms:modified xsi:type="dcterms:W3CDTF">2021-03-05T20:19:30Z</dcterms:modified>
</cp:coreProperties>
</file>